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5698" autoAdjust="0"/>
  </p:normalViewPr>
  <p:slideViewPr>
    <p:cSldViewPr>
      <p:cViewPr varScale="1">
        <p:scale>
          <a:sx n="62" d="100"/>
          <a:sy n="62" d="100"/>
        </p:scale>
        <p:origin x="1626" y="4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9E1626A-E5DB-4888-B6E9-B84407C3E8EF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66D5A9F-0F10-4483-BDCF-6A090BBB42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81540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ry Figure 5:</a:t>
            </a:r>
            <a:r>
              <a:rPr lang="en-US" baseline="0" dirty="0"/>
              <a:t> 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hromosomal microarray performed on DNA extracted from FFPE tissue using the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ncoScan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NV Plus assay for PSN-2</a:t>
            </a:r>
            <a:endParaRPr lang="en-US" dirty="0"/>
          </a:p>
          <a:p>
            <a:endParaRPr lang="en-US" dirty="0"/>
          </a:p>
          <a:p>
            <a:r>
              <a:rPr lang="en-US" dirty="0"/>
              <a:t>PSN-2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as classified as negative for copy number alterations and genomic deletions affecting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PCAT1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r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ERT.</a:t>
            </a: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66D5A9F-0F10-4483-BDCF-6A090BBB428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305264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32855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12159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1684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32179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71501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02996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7086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82842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57244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15118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94379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22789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5" name="Picture 1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" y="4560957"/>
            <a:ext cx="9016754" cy="140151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95401" y="0"/>
            <a:ext cx="7835798" cy="4495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Rectangle 4"/>
          <p:cNvSpPr/>
          <p:nvPr/>
        </p:nvSpPr>
        <p:spPr>
          <a:xfrm>
            <a:off x="381000" y="368595"/>
            <a:ext cx="74571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PSN-2</a:t>
            </a:r>
          </a:p>
        </p:txBody>
      </p:sp>
      <p:sp>
        <p:nvSpPr>
          <p:cNvPr id="2" name="Rectangle 1"/>
          <p:cNvSpPr/>
          <p:nvPr/>
        </p:nvSpPr>
        <p:spPr>
          <a:xfrm>
            <a:off x="76200" y="5962471"/>
            <a:ext cx="9016754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/>
              <a:t>S5 Fig:  </a:t>
            </a:r>
            <a:r>
              <a:rPr lang="en-US" dirty="0"/>
              <a:t>Chromosomal microarray performed on DNA extracted from FFPE tissue using the </a:t>
            </a:r>
            <a:r>
              <a:rPr lang="en-US" dirty="0" err="1"/>
              <a:t>OncoScan</a:t>
            </a:r>
            <a:r>
              <a:rPr lang="en-US" dirty="0"/>
              <a:t> CNV Plus assay for PSN-2.  PSN-2 was classified as negative for copy number alterations and genomic deletions affecting </a:t>
            </a:r>
            <a:r>
              <a:rPr lang="en-US" i="1" dirty="0"/>
              <a:t>LPCAT1 </a:t>
            </a:r>
            <a:r>
              <a:rPr lang="en-US" dirty="0"/>
              <a:t>or </a:t>
            </a:r>
            <a:r>
              <a:rPr lang="en-US" i="1" dirty="0"/>
              <a:t>TERT.</a:t>
            </a:r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795708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81</TotalTime>
  <Words>78</Words>
  <Application>Microsoft Office PowerPoint</Application>
  <PresentationFormat>On-screen Show (4:3)</PresentationFormat>
  <Paragraphs>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Mayo Clini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cole L Hoppman</dc:creator>
  <cp:lastModifiedBy>chn off31</cp:lastModifiedBy>
  <cp:revision>21</cp:revision>
  <dcterms:created xsi:type="dcterms:W3CDTF">2019-10-11T15:47:09Z</dcterms:created>
  <dcterms:modified xsi:type="dcterms:W3CDTF">2021-05-15T05:14:59Z</dcterms:modified>
</cp:coreProperties>
</file>